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3"/>
    <p:restoredTop sz="94677"/>
  </p:normalViewPr>
  <p:slideViewPr>
    <p:cSldViewPr snapToGrid="0" snapToObjects="1">
      <p:cViewPr varScale="1">
        <p:scale>
          <a:sx n="97" d="100"/>
          <a:sy n="97" d="100"/>
        </p:scale>
        <p:origin x="272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/C:\Users\Ata\Desktop\vha2%20body%20ben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1"/>
            <c:plus>
              <c:numRef>
                <c:f>Sheet1!$D$62:$D$68</c:f>
                <c:numCache>
                  <c:formatCode>General</c:formatCode>
                  <c:ptCount val="7"/>
                  <c:pt idx="0">
                    <c:v>0.06</c:v>
                  </c:pt>
                  <c:pt idx="1">
                    <c:v>0.28</c:v>
                  </c:pt>
                  <c:pt idx="2">
                    <c:v>0.002</c:v>
                  </c:pt>
                  <c:pt idx="3">
                    <c:v>0.003</c:v>
                  </c:pt>
                  <c:pt idx="4">
                    <c:v>0.144</c:v>
                  </c:pt>
                  <c:pt idx="5">
                    <c:v>0.09</c:v>
                  </c:pt>
                  <c:pt idx="6">
                    <c:v>0.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val>
            <c:numRef>
              <c:f>Sheet1!$C$62:$C$68</c:f>
              <c:numCache>
                <c:formatCode>General</c:formatCode>
                <c:ptCount val="7"/>
                <c:pt idx="0">
                  <c:v>0.66</c:v>
                </c:pt>
                <c:pt idx="1">
                  <c:v>0.48</c:v>
                </c:pt>
                <c:pt idx="2">
                  <c:v>0.569</c:v>
                </c:pt>
                <c:pt idx="3">
                  <c:v>0.663</c:v>
                </c:pt>
                <c:pt idx="4">
                  <c:v>0.444</c:v>
                </c:pt>
                <c:pt idx="5">
                  <c:v>0.477</c:v>
                </c:pt>
                <c:pt idx="6">
                  <c:v>0.5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4"/>
        <c:axId val="450970464"/>
        <c:axId val="451541424"/>
      </c:barChart>
      <c:catAx>
        <c:axId val="450970464"/>
        <c:scaling>
          <c:orientation val="minMax"/>
        </c:scaling>
        <c:delete val="1"/>
        <c:axPos val="l"/>
        <c:majorTickMark val="out"/>
        <c:minorTickMark val="none"/>
        <c:tickLblPos val="nextTo"/>
        <c:crossAx val="451541424"/>
        <c:crosses val="autoZero"/>
        <c:auto val="1"/>
        <c:lblAlgn val="ctr"/>
        <c:lblOffset val="100"/>
        <c:noMultiLvlLbl val="0"/>
      </c:catAx>
      <c:valAx>
        <c:axId val="451541424"/>
        <c:scaling>
          <c:orientation val="minMax"/>
          <c:max val="1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45097046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09F94-C459-354A-9588-6788093F4CCF}" type="datetimeFigureOut">
              <a:rPr lang="en-US" smtClean="0"/>
              <a:t>3/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FC67D-4A35-1F4F-A177-CF0F7601C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000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5"/>
          <p:cNvSpPr txBox="1"/>
          <p:nvPr/>
        </p:nvSpPr>
        <p:spPr>
          <a:xfrm>
            <a:off x="623109" y="386619"/>
            <a:ext cx="24921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 smtClean="0">
                <a:latin typeface="Times New Roman"/>
                <a:cs typeface="Times New Roman"/>
              </a:rPr>
              <a:t>Supplemental Figure </a:t>
            </a:r>
            <a:r>
              <a:rPr lang="en-CA" b="1" spc="15" dirty="0">
                <a:latin typeface="Times New Roman"/>
                <a:cs typeface="Times New Roman"/>
              </a:rPr>
              <a:t>2</a:t>
            </a:r>
            <a:endParaRPr dirty="0">
              <a:latin typeface="Times New Roman"/>
              <a:cs typeface="Times New Roman"/>
            </a:endParaRPr>
          </a:p>
        </p:txBody>
      </p:sp>
      <p:sp>
        <p:nvSpPr>
          <p:cNvPr id="5" name="object 84"/>
          <p:cNvSpPr txBox="1"/>
          <p:nvPr/>
        </p:nvSpPr>
        <p:spPr>
          <a:xfrm>
            <a:off x="529465" y="863221"/>
            <a:ext cx="1365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A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289578" y="1432333"/>
            <a:ext cx="3848096" cy="1447800"/>
            <a:chOff x="721310" y="3960842"/>
            <a:chExt cx="3848096" cy="1447800"/>
          </a:xfrm>
        </p:grpSpPr>
        <p:sp>
          <p:nvSpPr>
            <p:cNvPr id="7" name="TextBox 30"/>
            <p:cNvSpPr txBox="1">
              <a:spLocks noChangeArrowheads="1"/>
            </p:cNvSpPr>
            <p:nvPr/>
          </p:nvSpPr>
          <p:spPr bwMode="auto">
            <a:xfrm>
              <a:off x="721310" y="4554074"/>
              <a:ext cx="851031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6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35709" y="5147032"/>
              <a:ext cx="25629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/>
                  <a:cs typeface="Times New Roman"/>
                </a:rPr>
                <a:t>mRNA expression ratio in old:young cells  </a:t>
              </a:r>
              <a:endParaRPr lang="en-US" sz="1100" dirty="0">
                <a:latin typeface="Times New Roman"/>
                <a:cs typeface="Times New Roman"/>
              </a:endParaRPr>
            </a:p>
          </p:txBody>
        </p:sp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7946791"/>
                </p:ext>
              </p:extLst>
            </p:nvPr>
          </p:nvGraphicFramePr>
          <p:xfrm>
            <a:off x="1369006" y="3960842"/>
            <a:ext cx="3200400" cy="13230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30"/>
            <p:cNvSpPr txBox="1">
              <a:spLocks noChangeArrowheads="1"/>
            </p:cNvSpPr>
            <p:nvPr/>
          </p:nvSpPr>
          <p:spPr bwMode="auto">
            <a:xfrm>
              <a:off x="876598" y="4806015"/>
              <a:ext cx="69574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CA" sz="1100" i="1" kern="0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YPT7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30"/>
            <p:cNvSpPr txBox="1">
              <a:spLocks noChangeArrowheads="1"/>
            </p:cNvSpPr>
            <p:nvPr/>
          </p:nvSpPr>
          <p:spPr bwMode="auto">
            <a:xfrm>
              <a:off x="894041" y="4302136"/>
              <a:ext cx="67830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10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30"/>
            <p:cNvSpPr txBox="1">
              <a:spLocks noChangeArrowheads="1"/>
            </p:cNvSpPr>
            <p:nvPr/>
          </p:nvSpPr>
          <p:spPr bwMode="auto">
            <a:xfrm>
              <a:off x="792496" y="4428105"/>
              <a:ext cx="77984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8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30"/>
            <p:cNvSpPr txBox="1">
              <a:spLocks noChangeArrowheads="1"/>
            </p:cNvSpPr>
            <p:nvPr/>
          </p:nvSpPr>
          <p:spPr bwMode="auto">
            <a:xfrm>
              <a:off x="779791" y="4176167"/>
              <a:ext cx="79255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13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30"/>
            <p:cNvSpPr txBox="1">
              <a:spLocks noChangeArrowheads="1"/>
            </p:cNvSpPr>
            <p:nvPr/>
          </p:nvSpPr>
          <p:spPr bwMode="auto">
            <a:xfrm>
              <a:off x="779794" y="4050198"/>
              <a:ext cx="79254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21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>
              <a:spLocks noChangeArrowheads="1"/>
            </p:cNvSpPr>
            <p:nvPr/>
          </p:nvSpPr>
          <p:spPr bwMode="auto">
            <a:xfrm>
              <a:off x="876598" y="4680044"/>
              <a:ext cx="69574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CA" sz="1100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cs typeface="Times New Roman" pitchFamily="18" charset="0"/>
                </a:rPr>
                <a:t>VMA1</a:t>
              </a:r>
              <a:endParaRPr kumimoji="0" lang="en-CA" sz="11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" name="object 84"/>
          <p:cNvSpPr txBox="1"/>
          <p:nvPr/>
        </p:nvSpPr>
        <p:spPr>
          <a:xfrm>
            <a:off x="4006876" y="968171"/>
            <a:ext cx="136525" cy="27699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lang="en-CA" b="1" spc="15" dirty="0">
                <a:latin typeface="Times New Roman"/>
                <a:cs typeface="Times New Roman"/>
              </a:rPr>
              <a:t>B</a:t>
            </a:r>
            <a:endParaRPr dirty="0">
              <a:latin typeface="Times New Roman"/>
              <a:cs typeface="Times New Roman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4393907" y="660461"/>
            <a:ext cx="1977899" cy="2606528"/>
            <a:chOff x="871872" y="854099"/>
            <a:chExt cx="1977899" cy="2606528"/>
          </a:xfrm>
        </p:grpSpPr>
        <p:grpSp>
          <p:nvGrpSpPr>
            <p:cNvPr id="18" name="Group 17"/>
            <p:cNvGrpSpPr>
              <a:grpSpLocks/>
            </p:cNvGrpSpPr>
            <p:nvPr/>
          </p:nvGrpSpPr>
          <p:grpSpPr>
            <a:xfrm>
              <a:off x="871872" y="854099"/>
              <a:ext cx="1977899" cy="2606528"/>
              <a:chOff x="3431792" y="798503"/>
              <a:chExt cx="2029207" cy="2606528"/>
            </a:xfrm>
          </p:grpSpPr>
          <p:sp>
            <p:nvSpPr>
              <p:cNvPr id="23" name="object 122"/>
              <p:cNvSpPr txBox="1"/>
              <p:nvPr/>
            </p:nvSpPr>
            <p:spPr>
              <a:xfrm>
                <a:off x="4816059" y="1248677"/>
                <a:ext cx="644940" cy="459869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5875">
                  <a:lnSpc>
                    <a:spcPct val="90000"/>
                  </a:lnSpc>
                </a:pPr>
                <a:r>
                  <a:rPr sz="1100" spc="60" dirty="0">
                    <a:latin typeface="Times New Roman"/>
                    <a:cs typeface="Times New Roman"/>
                  </a:rPr>
                  <a:t>WT</a:t>
                </a:r>
                <a:r>
                  <a:rPr sz="1100" spc="-125" dirty="0">
                    <a:latin typeface="Times New Roman"/>
                    <a:cs typeface="Times New Roman"/>
                  </a:rPr>
                  <a:t> </a:t>
                </a:r>
                <a:endParaRPr sz="1100" dirty="0">
                  <a:latin typeface="Times New Roman"/>
                  <a:cs typeface="Times New Roman"/>
                </a:endParaRPr>
              </a:p>
              <a:p>
                <a:pPr marL="12700" marR="5080" indent="3175">
                  <a:lnSpc>
                    <a:spcPct val="90000"/>
                  </a:lnSpc>
                </a:pPr>
                <a:r>
                  <a:rPr sz="1100" i="1" spc="15" dirty="0">
                    <a:latin typeface="Times New Roman"/>
                    <a:cs typeface="Times New Roman"/>
                  </a:rPr>
                  <a:t>v</a:t>
                </a:r>
                <a:r>
                  <a:rPr sz="1100" i="1" spc="50" dirty="0">
                    <a:latin typeface="Times New Roman"/>
                    <a:cs typeface="Times New Roman"/>
                  </a:rPr>
                  <a:t>m</a:t>
                </a:r>
                <a:r>
                  <a:rPr sz="1100" i="1" spc="45" dirty="0">
                    <a:latin typeface="Times New Roman"/>
                    <a:cs typeface="Times New Roman"/>
                  </a:rPr>
                  <a:t>a</a:t>
                </a:r>
                <a:r>
                  <a:rPr sz="1100" i="1" spc="40" dirty="0">
                    <a:latin typeface="Times New Roman"/>
                    <a:cs typeface="Times New Roman"/>
                  </a:rPr>
                  <a:t>1</a:t>
                </a:r>
                <a:r>
                  <a:rPr sz="1100" spc="-150" dirty="0">
                    <a:latin typeface="Symbol"/>
                    <a:cs typeface="Symbol"/>
                  </a:rPr>
                  <a:t>D  </a:t>
                </a:r>
                <a:r>
                  <a:rPr sz="1100" i="1" spc="15" dirty="0">
                    <a:latin typeface="Times New Roman"/>
                    <a:cs typeface="Times New Roman"/>
                  </a:rPr>
                  <a:t>v</a:t>
                </a:r>
                <a:r>
                  <a:rPr sz="1100" i="1" spc="50" dirty="0">
                    <a:latin typeface="Times New Roman"/>
                    <a:cs typeface="Times New Roman"/>
                  </a:rPr>
                  <a:t>m</a:t>
                </a:r>
                <a:r>
                  <a:rPr sz="1100" i="1" spc="45" dirty="0">
                    <a:latin typeface="Times New Roman"/>
                    <a:cs typeface="Times New Roman"/>
                  </a:rPr>
                  <a:t>a8</a:t>
                </a:r>
                <a:r>
                  <a:rPr sz="1100" spc="-295" dirty="0">
                    <a:latin typeface="Symbol"/>
                    <a:cs typeface="Symbol"/>
                  </a:rPr>
                  <a:t>D</a:t>
                </a:r>
                <a:endParaRPr sz="1100" dirty="0">
                  <a:latin typeface="Symbol"/>
                  <a:cs typeface="Symbol"/>
                </a:endParaRPr>
              </a:p>
            </p:txBody>
          </p:sp>
          <p:sp>
            <p:nvSpPr>
              <p:cNvPr id="24" name="object 124"/>
              <p:cNvSpPr/>
              <p:nvPr/>
            </p:nvSpPr>
            <p:spPr>
              <a:xfrm>
                <a:off x="3956434" y="1253372"/>
                <a:ext cx="0" cy="1651587"/>
              </a:xfrm>
              <a:custGeom>
                <a:avLst/>
                <a:gdLst/>
                <a:ahLst/>
                <a:cxnLst/>
                <a:rect l="l" t="t" r="r" b="b"/>
                <a:pathLst>
                  <a:path h="1296035">
                    <a:moveTo>
                      <a:pt x="0" y="1295463"/>
                    </a:moveTo>
                    <a:lnTo>
                      <a:pt x="0" y="0"/>
                    </a:lnTo>
                  </a:path>
                </a:pathLst>
              </a:custGeom>
              <a:ln w="9525" cmpd="sng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25" name="object 125"/>
              <p:cNvSpPr/>
              <p:nvPr/>
            </p:nvSpPr>
            <p:spPr>
              <a:xfrm>
                <a:off x="3932159" y="2904231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26" name="object 126"/>
              <p:cNvSpPr/>
              <p:nvPr/>
            </p:nvSpPr>
            <p:spPr>
              <a:xfrm>
                <a:off x="3932159" y="2661469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27" name="object 127"/>
              <p:cNvSpPr/>
              <p:nvPr/>
            </p:nvSpPr>
            <p:spPr>
              <a:xfrm>
                <a:off x="3932159" y="2430846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28" name="object 128"/>
              <p:cNvSpPr/>
              <p:nvPr/>
            </p:nvSpPr>
            <p:spPr>
              <a:xfrm>
                <a:off x="3932159" y="2188166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29" name="object 129"/>
              <p:cNvSpPr/>
              <p:nvPr/>
            </p:nvSpPr>
            <p:spPr>
              <a:xfrm>
                <a:off x="3932159" y="1957542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30" name="object 130"/>
              <p:cNvSpPr/>
              <p:nvPr/>
            </p:nvSpPr>
            <p:spPr>
              <a:xfrm>
                <a:off x="3932159" y="1714618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31" name="object 131"/>
              <p:cNvSpPr/>
              <p:nvPr/>
            </p:nvSpPr>
            <p:spPr>
              <a:xfrm>
                <a:off x="3932159" y="1483994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32" name="object 132"/>
              <p:cNvSpPr/>
              <p:nvPr/>
            </p:nvSpPr>
            <p:spPr>
              <a:xfrm>
                <a:off x="3932159" y="1253372"/>
                <a:ext cx="24276" cy="0"/>
              </a:xfrm>
              <a:custGeom>
                <a:avLst/>
                <a:gdLst/>
                <a:ahLst/>
                <a:cxnLst/>
                <a:rect l="l" t="t" r="r" b="b"/>
                <a:pathLst>
                  <a:path w="19050">
                    <a:moveTo>
                      <a:pt x="0" y="0"/>
                    </a:moveTo>
                    <a:lnTo>
                      <a:pt x="19050" y="0"/>
                    </a:lnTo>
                  </a:path>
                </a:pathLst>
              </a:custGeom>
              <a:ln w="9525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33" name="object 133"/>
              <p:cNvSpPr/>
              <p:nvPr/>
            </p:nvSpPr>
            <p:spPr>
              <a:xfrm>
                <a:off x="3956434" y="2904231"/>
                <a:ext cx="960279" cy="0"/>
              </a:xfrm>
              <a:custGeom>
                <a:avLst/>
                <a:gdLst/>
                <a:ahLst/>
                <a:cxnLst/>
                <a:rect l="l" t="t" r="r" b="b"/>
                <a:pathLst>
                  <a:path w="704850">
                    <a:moveTo>
                      <a:pt x="0" y="0"/>
                    </a:moveTo>
                    <a:lnTo>
                      <a:pt x="704850" y="0"/>
                    </a:lnTo>
                  </a:path>
                </a:pathLst>
              </a:custGeom>
              <a:ln w="9525" cmpd="sng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4" name="object 134"/>
              <p:cNvSpPr/>
              <p:nvPr/>
            </p:nvSpPr>
            <p:spPr>
              <a:xfrm>
                <a:off x="3950365" y="2916369"/>
                <a:ext cx="12138" cy="0"/>
              </a:xfrm>
              <a:custGeom>
                <a:avLst/>
                <a:gdLst/>
                <a:ahLst/>
                <a:cxnLst/>
                <a:rect l="l" t="t" r="r" b="b"/>
                <a:pathLst>
                  <a:path w="9525">
                    <a:moveTo>
                      <a:pt x="0" y="0"/>
                    </a:moveTo>
                    <a:lnTo>
                      <a:pt x="9525" y="0"/>
                    </a:lnTo>
                  </a:path>
                </a:pathLst>
              </a:custGeom>
              <a:ln w="19050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 sz="1000"/>
              </a:p>
            </p:txBody>
          </p:sp>
          <p:sp>
            <p:nvSpPr>
              <p:cNvPr id="35" name="object 135"/>
              <p:cNvSpPr/>
              <p:nvPr/>
            </p:nvSpPr>
            <p:spPr>
              <a:xfrm>
                <a:off x="4253816" y="2916369"/>
                <a:ext cx="12138" cy="0"/>
              </a:xfrm>
              <a:custGeom>
                <a:avLst/>
                <a:gdLst/>
                <a:ahLst/>
                <a:cxnLst/>
                <a:rect l="l" t="t" r="r" b="b"/>
                <a:pathLst>
                  <a:path w="9525">
                    <a:moveTo>
                      <a:pt x="0" y="0"/>
                    </a:moveTo>
                    <a:lnTo>
                      <a:pt x="9525" y="0"/>
                    </a:lnTo>
                  </a:path>
                </a:pathLst>
              </a:custGeom>
              <a:ln w="19050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6" name="object 136"/>
              <p:cNvSpPr/>
              <p:nvPr/>
            </p:nvSpPr>
            <p:spPr>
              <a:xfrm>
                <a:off x="4557268" y="2916369"/>
                <a:ext cx="12138" cy="0"/>
              </a:xfrm>
              <a:custGeom>
                <a:avLst/>
                <a:gdLst/>
                <a:ahLst/>
                <a:cxnLst/>
                <a:rect l="l" t="t" r="r" b="b"/>
                <a:pathLst>
                  <a:path w="9525">
                    <a:moveTo>
                      <a:pt x="0" y="0"/>
                    </a:moveTo>
                    <a:lnTo>
                      <a:pt x="9525" y="0"/>
                    </a:lnTo>
                  </a:path>
                </a:pathLst>
              </a:custGeom>
              <a:ln w="19050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7" name="object 137"/>
              <p:cNvSpPr/>
              <p:nvPr/>
            </p:nvSpPr>
            <p:spPr>
              <a:xfrm>
                <a:off x="4848581" y="2916369"/>
                <a:ext cx="12138" cy="0"/>
              </a:xfrm>
              <a:custGeom>
                <a:avLst/>
                <a:gdLst/>
                <a:ahLst/>
                <a:cxnLst/>
                <a:rect l="l" t="t" r="r" b="b"/>
                <a:pathLst>
                  <a:path w="9525">
                    <a:moveTo>
                      <a:pt x="0" y="0"/>
                    </a:moveTo>
                    <a:lnTo>
                      <a:pt x="9525" y="0"/>
                    </a:lnTo>
                  </a:path>
                </a:pathLst>
              </a:custGeom>
              <a:ln w="19050">
                <a:solidFill>
                  <a:srgbClr val="858585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8" name="object 138"/>
              <p:cNvSpPr/>
              <p:nvPr/>
            </p:nvSpPr>
            <p:spPr>
              <a:xfrm>
                <a:off x="4266198" y="2512672"/>
                <a:ext cx="289694" cy="363334"/>
              </a:xfrm>
              <a:custGeom>
                <a:avLst/>
                <a:gdLst/>
                <a:ahLst/>
                <a:cxnLst/>
                <a:rect l="l" t="t" r="r" b="b"/>
                <a:pathLst>
                  <a:path w="227330" h="285114">
                    <a:moveTo>
                      <a:pt x="0" y="281774"/>
                    </a:moveTo>
                    <a:lnTo>
                      <a:pt x="4635" y="259062"/>
                    </a:lnTo>
                    <a:lnTo>
                      <a:pt x="11271" y="226599"/>
                    </a:lnTo>
                    <a:lnTo>
                      <a:pt x="18716" y="189374"/>
                    </a:lnTo>
                    <a:lnTo>
                      <a:pt x="25781" y="152374"/>
                    </a:lnTo>
                    <a:lnTo>
                      <a:pt x="32291" y="110304"/>
                    </a:lnTo>
                    <a:lnTo>
                      <a:pt x="38814" y="62704"/>
                    </a:lnTo>
                    <a:lnTo>
                      <a:pt x="45265" y="21845"/>
                    </a:lnTo>
                    <a:lnTo>
                      <a:pt x="51562" y="0"/>
                    </a:lnTo>
                    <a:lnTo>
                      <a:pt x="57499" y="5280"/>
                    </a:lnTo>
                    <a:lnTo>
                      <a:pt x="63245" y="29529"/>
                    </a:lnTo>
                    <a:lnTo>
                      <a:pt x="68992" y="60609"/>
                    </a:lnTo>
                    <a:lnTo>
                      <a:pt x="74929" y="86385"/>
                    </a:lnTo>
                    <a:lnTo>
                      <a:pt x="94253" y="137615"/>
                    </a:lnTo>
                    <a:lnTo>
                      <a:pt x="113744" y="180435"/>
                    </a:lnTo>
                    <a:lnTo>
                      <a:pt x="138223" y="220562"/>
                    </a:lnTo>
                    <a:lnTo>
                      <a:pt x="169183" y="249899"/>
                    </a:lnTo>
                    <a:lnTo>
                      <a:pt x="194964" y="264236"/>
                    </a:lnTo>
                    <a:lnTo>
                      <a:pt x="201421" y="267677"/>
                    </a:lnTo>
                    <a:lnTo>
                      <a:pt x="207879" y="271714"/>
                    </a:lnTo>
                    <a:lnTo>
                      <a:pt x="214312" y="276059"/>
                    </a:lnTo>
                    <a:lnTo>
                      <a:pt x="220745" y="280529"/>
                    </a:lnTo>
                    <a:lnTo>
                      <a:pt x="227202" y="284937"/>
                    </a:lnTo>
                  </a:path>
                </a:pathLst>
              </a:custGeom>
              <a:ln w="19050">
                <a:solidFill>
                  <a:srgbClr val="3366F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39" name="object 139"/>
              <p:cNvSpPr/>
              <p:nvPr/>
            </p:nvSpPr>
            <p:spPr>
              <a:xfrm>
                <a:off x="4266198" y="2253796"/>
                <a:ext cx="289694" cy="609331"/>
              </a:xfrm>
              <a:custGeom>
                <a:avLst/>
                <a:gdLst/>
                <a:ahLst/>
                <a:cxnLst/>
                <a:rect l="l" t="t" r="r" b="b"/>
                <a:pathLst>
                  <a:path w="227330" h="478154">
                    <a:moveTo>
                      <a:pt x="0" y="477580"/>
                    </a:moveTo>
                    <a:lnTo>
                      <a:pt x="4635" y="437316"/>
                    </a:lnTo>
                    <a:lnTo>
                      <a:pt x="11271" y="379667"/>
                    </a:lnTo>
                    <a:lnTo>
                      <a:pt x="18716" y="314225"/>
                    </a:lnTo>
                    <a:lnTo>
                      <a:pt x="25781" y="250580"/>
                    </a:lnTo>
                    <a:lnTo>
                      <a:pt x="30985" y="196636"/>
                    </a:lnTo>
                    <a:lnTo>
                      <a:pt x="36209" y="135934"/>
                    </a:lnTo>
                    <a:lnTo>
                      <a:pt x="41408" y="77268"/>
                    </a:lnTo>
                    <a:lnTo>
                      <a:pt x="46539" y="29434"/>
                    </a:lnTo>
                    <a:lnTo>
                      <a:pt x="51562" y="1228"/>
                    </a:lnTo>
                    <a:lnTo>
                      <a:pt x="57499" y="0"/>
                    </a:lnTo>
                    <a:lnTo>
                      <a:pt x="63245" y="25175"/>
                    </a:lnTo>
                    <a:lnTo>
                      <a:pt x="68992" y="62070"/>
                    </a:lnTo>
                    <a:lnTo>
                      <a:pt x="74929" y="95995"/>
                    </a:lnTo>
                    <a:lnTo>
                      <a:pt x="81244" y="126143"/>
                    </a:lnTo>
                    <a:lnTo>
                      <a:pt x="87725" y="159318"/>
                    </a:lnTo>
                    <a:lnTo>
                      <a:pt x="94253" y="192225"/>
                    </a:lnTo>
                    <a:lnTo>
                      <a:pt x="107221" y="246440"/>
                    </a:lnTo>
                    <a:lnTo>
                      <a:pt x="120195" y="288789"/>
                    </a:lnTo>
                    <a:lnTo>
                      <a:pt x="132482" y="325533"/>
                    </a:lnTo>
                    <a:lnTo>
                      <a:pt x="149859" y="370430"/>
                    </a:lnTo>
                    <a:lnTo>
                      <a:pt x="169183" y="404016"/>
                    </a:lnTo>
                    <a:lnTo>
                      <a:pt x="194964" y="440522"/>
                    </a:lnTo>
                    <a:lnTo>
                      <a:pt x="220745" y="463843"/>
                    </a:lnTo>
                    <a:lnTo>
                      <a:pt x="227202" y="468740"/>
                    </a:lnTo>
                  </a:path>
                </a:pathLst>
              </a:custGeom>
              <a:ln w="19050">
                <a:solidFill>
                  <a:srgbClr val="FF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40" name="object 140"/>
              <p:cNvSpPr/>
              <p:nvPr/>
            </p:nvSpPr>
            <p:spPr>
              <a:xfrm>
                <a:off x="4266198" y="1466594"/>
                <a:ext cx="289694" cy="1365938"/>
              </a:xfrm>
              <a:custGeom>
                <a:avLst/>
                <a:gdLst/>
                <a:ahLst/>
                <a:cxnLst/>
                <a:rect l="l" t="t" r="r" b="b"/>
                <a:pathLst>
                  <a:path w="227330" h="1071879">
                    <a:moveTo>
                      <a:pt x="0" y="1071781"/>
                    </a:moveTo>
                    <a:lnTo>
                      <a:pt x="2712" y="1043839"/>
                    </a:lnTo>
                    <a:lnTo>
                      <a:pt x="6712" y="1005779"/>
                    </a:lnTo>
                    <a:lnTo>
                      <a:pt x="11509" y="958086"/>
                    </a:lnTo>
                    <a:lnTo>
                      <a:pt x="16613" y="901245"/>
                    </a:lnTo>
                    <a:lnTo>
                      <a:pt x="21534" y="835743"/>
                    </a:lnTo>
                    <a:lnTo>
                      <a:pt x="25781" y="762066"/>
                    </a:lnTo>
                    <a:lnTo>
                      <a:pt x="27511" y="722763"/>
                    </a:lnTo>
                    <a:lnTo>
                      <a:pt x="29246" y="676264"/>
                    </a:lnTo>
                    <a:lnTo>
                      <a:pt x="30985" y="623882"/>
                    </a:lnTo>
                    <a:lnTo>
                      <a:pt x="32727" y="566927"/>
                    </a:lnTo>
                    <a:lnTo>
                      <a:pt x="34468" y="506711"/>
                    </a:lnTo>
                    <a:lnTo>
                      <a:pt x="36209" y="444547"/>
                    </a:lnTo>
                    <a:lnTo>
                      <a:pt x="37946" y="381745"/>
                    </a:lnTo>
                    <a:lnTo>
                      <a:pt x="39680" y="319617"/>
                    </a:lnTo>
                    <a:lnTo>
                      <a:pt x="41408" y="259475"/>
                    </a:lnTo>
                    <a:lnTo>
                      <a:pt x="43128" y="202631"/>
                    </a:lnTo>
                    <a:lnTo>
                      <a:pt x="44839" y="150396"/>
                    </a:lnTo>
                    <a:lnTo>
                      <a:pt x="46539" y="104082"/>
                    </a:lnTo>
                    <a:lnTo>
                      <a:pt x="48228" y="65000"/>
                    </a:lnTo>
                    <a:lnTo>
                      <a:pt x="51562" y="13782"/>
                    </a:lnTo>
                    <a:lnTo>
                      <a:pt x="54236" y="0"/>
                    </a:lnTo>
                    <a:lnTo>
                      <a:pt x="56852" y="7098"/>
                    </a:lnTo>
                    <a:lnTo>
                      <a:pt x="61975" y="67785"/>
                    </a:lnTo>
                    <a:lnTo>
                      <a:pt x="64516" y="113294"/>
                    </a:lnTo>
                    <a:lnTo>
                      <a:pt x="67065" y="163529"/>
                    </a:lnTo>
                    <a:lnTo>
                      <a:pt x="69639" y="214451"/>
                    </a:lnTo>
                    <a:lnTo>
                      <a:pt x="72255" y="262020"/>
                    </a:lnTo>
                    <a:lnTo>
                      <a:pt x="74929" y="302199"/>
                    </a:lnTo>
                    <a:lnTo>
                      <a:pt x="78510" y="350155"/>
                    </a:lnTo>
                    <a:lnTo>
                      <a:pt x="82162" y="402201"/>
                    </a:lnTo>
                    <a:lnTo>
                      <a:pt x="85863" y="456125"/>
                    </a:lnTo>
                    <a:lnTo>
                      <a:pt x="89590" y="509718"/>
                    </a:lnTo>
                    <a:lnTo>
                      <a:pt x="93322" y="560772"/>
                    </a:lnTo>
                    <a:lnTo>
                      <a:pt x="97036" y="607075"/>
                    </a:lnTo>
                    <a:lnTo>
                      <a:pt x="100710" y="646420"/>
                    </a:lnTo>
                    <a:lnTo>
                      <a:pt x="107007" y="695730"/>
                    </a:lnTo>
                    <a:lnTo>
                      <a:pt x="113744" y="734367"/>
                    </a:lnTo>
                    <a:lnTo>
                      <a:pt x="126491" y="793892"/>
                    </a:lnTo>
                    <a:lnTo>
                      <a:pt x="138223" y="844846"/>
                    </a:lnTo>
                    <a:lnTo>
                      <a:pt x="149859" y="887847"/>
                    </a:lnTo>
                    <a:lnTo>
                      <a:pt x="162655" y="932406"/>
                    </a:lnTo>
                    <a:lnTo>
                      <a:pt x="175640" y="971679"/>
                    </a:lnTo>
                    <a:lnTo>
                      <a:pt x="194964" y="1012358"/>
                    </a:lnTo>
                    <a:lnTo>
                      <a:pt x="220745" y="1049433"/>
                    </a:lnTo>
                    <a:lnTo>
                      <a:pt x="227202" y="1057608"/>
                    </a:lnTo>
                  </a:path>
                </a:pathLst>
              </a:custGeom>
              <a:ln w="19049">
                <a:solidFill>
                  <a:schemeClr val="tx1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41" name="object 141"/>
              <p:cNvSpPr txBox="1"/>
              <p:nvPr/>
            </p:nvSpPr>
            <p:spPr>
              <a:xfrm>
                <a:off x="3822430" y="2825812"/>
                <a:ext cx="80921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</a:pPr>
                <a:r>
                  <a:rPr sz="1000" dirty="0">
                    <a:latin typeface="Times New Roman"/>
                    <a:cs typeface="Times New Roman"/>
                  </a:rPr>
                  <a:t>0</a:t>
                </a:r>
              </a:p>
            </p:txBody>
          </p:sp>
          <p:sp>
            <p:nvSpPr>
              <p:cNvPr id="42" name="object 142"/>
              <p:cNvSpPr txBox="1"/>
              <p:nvPr/>
            </p:nvSpPr>
            <p:spPr>
              <a:xfrm>
                <a:off x="3599815" y="2589344"/>
                <a:ext cx="30321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sz="1000" dirty="0">
                    <a:latin typeface="Times New Roman"/>
                    <a:cs typeface="Times New Roman"/>
                  </a:rPr>
                  <a:t>500</a:t>
                </a:r>
              </a:p>
            </p:txBody>
          </p:sp>
          <p:sp>
            <p:nvSpPr>
              <p:cNvPr id="43" name="object 143"/>
              <p:cNvSpPr txBox="1"/>
              <p:nvPr/>
            </p:nvSpPr>
            <p:spPr>
              <a:xfrm>
                <a:off x="3599815" y="2352875"/>
                <a:ext cx="30321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sz="1000" spc="-5" dirty="0">
                    <a:latin typeface="Times New Roman"/>
                    <a:cs typeface="Times New Roman"/>
                  </a:rPr>
                  <a:t>1000</a:t>
                </a:r>
                <a:endParaRPr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44" name="object 144"/>
              <p:cNvSpPr txBox="1"/>
              <p:nvPr/>
            </p:nvSpPr>
            <p:spPr>
              <a:xfrm>
                <a:off x="3599815" y="2116405"/>
                <a:ext cx="30321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sz="1000" dirty="0">
                    <a:latin typeface="Times New Roman"/>
                    <a:cs typeface="Times New Roman"/>
                  </a:rPr>
                  <a:t>1500</a:t>
                </a:r>
              </a:p>
            </p:txBody>
          </p:sp>
          <p:sp>
            <p:nvSpPr>
              <p:cNvPr id="45" name="object 145"/>
              <p:cNvSpPr txBox="1"/>
              <p:nvPr/>
            </p:nvSpPr>
            <p:spPr>
              <a:xfrm>
                <a:off x="3599815" y="1879935"/>
                <a:ext cx="30321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sz="1000" dirty="0">
                    <a:latin typeface="Times New Roman"/>
                    <a:cs typeface="Times New Roman"/>
                  </a:rPr>
                  <a:t>2000</a:t>
                </a:r>
              </a:p>
            </p:txBody>
          </p:sp>
          <p:sp>
            <p:nvSpPr>
              <p:cNvPr id="46" name="object 146"/>
              <p:cNvSpPr txBox="1"/>
              <p:nvPr/>
            </p:nvSpPr>
            <p:spPr>
              <a:xfrm>
                <a:off x="3599815" y="1643466"/>
                <a:ext cx="30321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sz="1000" spc="-5" dirty="0">
                    <a:latin typeface="Times New Roman"/>
                    <a:cs typeface="Times New Roman"/>
                  </a:rPr>
                  <a:t>2500</a:t>
                </a:r>
                <a:endParaRPr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3718055" y="3158810"/>
                <a:ext cx="160720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12700" algn="ctr">
                  <a:lnSpc>
                    <a:spcPct val="100000"/>
                  </a:lnSpc>
                  <a:spcBef>
                    <a:spcPts val="380"/>
                  </a:spcBef>
                </a:pPr>
                <a:r>
                  <a:rPr lang="en-US" sz="1000" spc="35" dirty="0">
                    <a:latin typeface="Times New Roman"/>
                    <a:cs typeface="Times New Roman"/>
                  </a:rPr>
                  <a:t>Emission </a:t>
                </a:r>
                <a:r>
                  <a:rPr lang="en-US" sz="1000" spc="10" dirty="0">
                    <a:latin typeface="Times New Roman"/>
                    <a:cs typeface="Times New Roman"/>
                  </a:rPr>
                  <a:t>wavelength</a:t>
                </a:r>
                <a:r>
                  <a:rPr lang="en-US" sz="1000" spc="-15" dirty="0">
                    <a:latin typeface="Times New Roman"/>
                    <a:cs typeface="Times New Roman"/>
                  </a:rPr>
                  <a:t> </a:t>
                </a:r>
                <a:r>
                  <a:rPr lang="en-US" sz="1000" spc="20" dirty="0">
                    <a:latin typeface="Times New Roman"/>
                    <a:cs typeface="Times New Roman"/>
                  </a:rPr>
                  <a:t>(nm)</a:t>
                </a:r>
                <a:endParaRPr lang="en-US"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48" name="object 146"/>
              <p:cNvSpPr txBox="1"/>
              <p:nvPr/>
            </p:nvSpPr>
            <p:spPr>
              <a:xfrm>
                <a:off x="3599815" y="1406996"/>
                <a:ext cx="309422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lang="en-CA" sz="1000" spc="-5" dirty="0" smtClean="0">
                    <a:latin typeface="Times New Roman"/>
                    <a:cs typeface="Times New Roman"/>
                  </a:rPr>
                  <a:t>30</a:t>
                </a:r>
                <a:r>
                  <a:rPr sz="1000" spc="-5" dirty="0" smtClean="0">
                    <a:latin typeface="Times New Roman"/>
                    <a:cs typeface="Times New Roman"/>
                  </a:rPr>
                  <a:t>00</a:t>
                </a:r>
                <a:endParaRPr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49" name="object 146"/>
              <p:cNvSpPr txBox="1"/>
              <p:nvPr/>
            </p:nvSpPr>
            <p:spPr>
              <a:xfrm>
                <a:off x="3516970" y="1170527"/>
                <a:ext cx="392268" cy="153888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 marL="12700" algn="r">
                  <a:lnSpc>
                    <a:spcPct val="100000"/>
                  </a:lnSpc>
                </a:pPr>
                <a:r>
                  <a:rPr lang="en-CA" sz="1000" spc="-5" dirty="0">
                    <a:latin typeface="Times New Roman"/>
                    <a:cs typeface="Times New Roman"/>
                  </a:rPr>
                  <a:t>3</a:t>
                </a:r>
                <a:r>
                  <a:rPr sz="1000" spc="-5" dirty="0" smtClean="0">
                    <a:latin typeface="Times New Roman"/>
                    <a:cs typeface="Times New Roman"/>
                  </a:rPr>
                  <a:t>500</a:t>
                </a:r>
                <a:endParaRPr sz="10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50" name="object 34"/>
              <p:cNvSpPr txBox="1"/>
              <p:nvPr/>
            </p:nvSpPr>
            <p:spPr>
              <a:xfrm>
                <a:off x="3431792" y="798503"/>
                <a:ext cx="113915" cy="2542915"/>
              </a:xfrm>
              <a:prstGeom prst="rect">
                <a:avLst/>
              </a:prstGeom>
            </p:spPr>
            <p:txBody>
              <a:bodyPr vert="vert270" wrap="square" lIns="0" tIns="0" rIns="0" bIns="0" rtlCol="0">
                <a:spAutoFit/>
              </a:bodyPr>
              <a:lstStyle/>
              <a:p>
                <a:pPr marL="12700" algn="ctr">
                  <a:lnSpc>
                    <a:spcPts val="775"/>
                  </a:lnSpc>
                </a:pPr>
                <a:r>
                  <a:rPr lang="en-CA" sz="1100" spc="-40" dirty="0" smtClean="0">
                    <a:latin typeface="Times New Roman"/>
                    <a:cs typeface="Times New Roman"/>
                  </a:rPr>
                  <a:t>CMAC f</a:t>
                </a:r>
                <a:r>
                  <a:rPr sz="1100" spc="35" dirty="0" smtClean="0">
                    <a:latin typeface="Times New Roman"/>
                    <a:cs typeface="Times New Roman"/>
                  </a:rPr>
                  <a:t>l</a:t>
                </a:r>
                <a:r>
                  <a:rPr sz="1100" dirty="0" smtClean="0">
                    <a:latin typeface="Times New Roman"/>
                    <a:cs typeface="Times New Roman"/>
                  </a:rPr>
                  <a:t>u</a:t>
                </a:r>
                <a:r>
                  <a:rPr sz="1100" spc="35" dirty="0" smtClean="0">
                    <a:latin typeface="Times New Roman"/>
                    <a:cs typeface="Times New Roman"/>
                  </a:rPr>
                  <a:t>o</a:t>
                </a:r>
                <a:r>
                  <a:rPr sz="1100" dirty="0" smtClean="0">
                    <a:latin typeface="Times New Roman"/>
                    <a:cs typeface="Times New Roman"/>
                  </a:rPr>
                  <a:t>re</a:t>
                </a:r>
                <a:r>
                  <a:rPr sz="1100" spc="35" dirty="0" smtClean="0">
                    <a:latin typeface="Times New Roman"/>
                    <a:cs typeface="Times New Roman"/>
                  </a:rPr>
                  <a:t>s</a:t>
                </a:r>
                <a:r>
                  <a:rPr sz="1100" dirty="0" smtClean="0">
                    <a:latin typeface="Times New Roman"/>
                    <a:cs typeface="Times New Roman"/>
                  </a:rPr>
                  <a:t>cence  </a:t>
                </a:r>
                <a:r>
                  <a:rPr sz="1100" spc="-40" dirty="0" smtClean="0">
                    <a:latin typeface="Times New Roman"/>
                    <a:cs typeface="Times New Roman"/>
                  </a:rPr>
                  <a:t> </a:t>
                </a:r>
                <a:r>
                  <a:rPr sz="1100" spc="35" dirty="0">
                    <a:latin typeface="Times New Roman"/>
                    <a:cs typeface="Times New Roman"/>
                  </a:rPr>
                  <a:t>i</a:t>
                </a:r>
                <a:r>
                  <a:rPr sz="1100" dirty="0">
                    <a:latin typeface="Times New Roman"/>
                    <a:cs typeface="Times New Roman"/>
                  </a:rPr>
                  <a:t>nten</a:t>
                </a:r>
                <a:r>
                  <a:rPr sz="1100" spc="35" dirty="0">
                    <a:latin typeface="Times New Roman"/>
                    <a:cs typeface="Times New Roman"/>
                  </a:rPr>
                  <a:t>si</a:t>
                </a:r>
                <a:r>
                  <a:rPr sz="1100" dirty="0">
                    <a:latin typeface="Times New Roman"/>
                    <a:cs typeface="Times New Roman"/>
                  </a:rPr>
                  <a:t>ty</a:t>
                </a:r>
              </a:p>
            </p:txBody>
          </p:sp>
          <p:sp>
            <p:nvSpPr>
              <p:cNvPr id="51" name="object 53"/>
              <p:cNvSpPr/>
              <p:nvPr/>
            </p:nvSpPr>
            <p:spPr>
              <a:xfrm>
                <a:off x="4658692" y="1475699"/>
                <a:ext cx="117418" cy="0"/>
              </a:xfrm>
              <a:custGeom>
                <a:avLst/>
                <a:gdLst/>
                <a:ahLst/>
                <a:cxnLst/>
                <a:rect l="l" t="t" r="r" b="b"/>
                <a:pathLst>
                  <a:path w="45084">
                    <a:moveTo>
                      <a:pt x="0" y="0"/>
                    </a:moveTo>
                    <a:lnTo>
                      <a:pt x="44957" y="0"/>
                    </a:lnTo>
                  </a:path>
                </a:pathLst>
              </a:custGeom>
              <a:ln w="19050">
                <a:solidFill>
                  <a:srgbClr val="FF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52" name="object 54"/>
              <p:cNvSpPr/>
              <p:nvPr/>
            </p:nvSpPr>
            <p:spPr>
              <a:xfrm>
                <a:off x="4658692" y="1320435"/>
                <a:ext cx="117418" cy="0"/>
              </a:xfrm>
              <a:custGeom>
                <a:avLst/>
                <a:gdLst/>
                <a:ahLst/>
                <a:cxnLst/>
                <a:rect l="l" t="t" r="r" b="b"/>
                <a:pathLst>
                  <a:path w="45084">
                    <a:moveTo>
                      <a:pt x="0" y="0"/>
                    </a:moveTo>
                    <a:lnTo>
                      <a:pt x="45084" y="0"/>
                    </a:lnTo>
                  </a:path>
                </a:pathLst>
              </a:custGeom>
              <a:ln w="190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53" name="object 53"/>
              <p:cNvSpPr/>
              <p:nvPr/>
            </p:nvSpPr>
            <p:spPr>
              <a:xfrm>
                <a:off x="4658692" y="1638852"/>
                <a:ext cx="117418" cy="0"/>
              </a:xfrm>
              <a:custGeom>
                <a:avLst/>
                <a:gdLst/>
                <a:ahLst/>
                <a:cxnLst/>
                <a:rect l="l" t="t" r="r" b="b"/>
                <a:pathLst>
                  <a:path w="45084">
                    <a:moveTo>
                      <a:pt x="0" y="0"/>
                    </a:moveTo>
                    <a:lnTo>
                      <a:pt x="44957" y="0"/>
                    </a:lnTo>
                  </a:path>
                </a:pathLst>
              </a:custGeom>
              <a:ln w="19050">
                <a:solidFill>
                  <a:srgbClr val="3366FF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9" name="TextBox 18"/>
            <p:cNvSpPr txBox="1"/>
            <p:nvPr/>
          </p:nvSpPr>
          <p:spPr>
            <a:xfrm>
              <a:off x="1187432" y="3003662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4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76032" y="3003662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Times New Roman"/>
                  <a:cs typeface="Times New Roman"/>
                </a:rPr>
                <a:t>5</a:t>
              </a:r>
              <a:r>
                <a:rPr lang="en-US" sz="1000" dirty="0" smtClean="0">
                  <a:latin typeface="Times New Roman"/>
                  <a:cs typeface="Times New Roman"/>
                </a:rPr>
                <a:t>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76501" y="3003662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>
                  <a:latin typeface="Times New Roman"/>
                  <a:cs typeface="Times New Roman"/>
                </a:rPr>
                <a:t>6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59167" y="3003662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Times New Roman"/>
                  <a:cs typeface="Times New Roman"/>
                </a:rPr>
                <a:t>7</a:t>
              </a:r>
              <a:r>
                <a:rPr lang="en-US" sz="1000" dirty="0" smtClean="0">
                  <a:latin typeface="Times New Roman"/>
                  <a:cs typeface="Times New Roman"/>
                </a:rPr>
                <a:t>00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67025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Symbol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18-03-07T20:34:28Z</dcterms:created>
  <dcterms:modified xsi:type="dcterms:W3CDTF">2018-03-07T20:35:09Z</dcterms:modified>
</cp:coreProperties>
</file>